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1" r:id="rId6"/>
    <p:sldId id="260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96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18CE03-6EB6-A4D6-7B48-6B2E139E7F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DC88D91-80EF-A1D6-60F7-B4659D9315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260D773-65AF-54CC-71D2-B03A55B951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F722F-EB21-4902-A374-E95D4CAE7E36}" type="datetimeFigureOut">
              <a:rPr lang="zh-CN" altLang="en-US" smtClean="0"/>
              <a:t>2025/9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CABA4D2-CC35-D820-9F9B-A735AE9663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2A69DF8-AF0D-70CF-B0D0-2A8D508CC7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5B7DC-5966-45AC-92B7-C8CED918E5F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8461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EDE719-8B6B-CB05-105A-BDCC4A7511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BD80E63-6AC3-DCEF-D5DC-330F9CAD9C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642BC1D-3BA2-7CF3-EA37-3C6B33B69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F722F-EB21-4902-A374-E95D4CAE7E36}" type="datetimeFigureOut">
              <a:rPr lang="zh-CN" altLang="en-US" smtClean="0"/>
              <a:t>2025/9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1EA6BC5-0C19-B67E-D0BF-A90E4DD7C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5D8381B-EA77-1D56-3975-E4FE33A04C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5B7DC-5966-45AC-92B7-C8CED918E5F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5897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4C28331-7C9A-6284-EBEE-1549C441D61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549D49E-6E34-9EF8-A1A5-34CCC39511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201BB3C-8D63-B84B-5924-A7E25C469D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F722F-EB21-4902-A374-E95D4CAE7E36}" type="datetimeFigureOut">
              <a:rPr lang="zh-CN" altLang="en-US" smtClean="0"/>
              <a:t>2025/9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3F8AE82-CCF6-B5FE-96CA-A4BCC0C5D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D8A6B32-985D-EF80-029A-865DDE5B2D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5B7DC-5966-45AC-92B7-C8CED918E5F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38869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0521C8-50DB-C877-E8E2-E98118C004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4927C52-1B70-C109-E1F7-B6C0933117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6D4C53-E419-5371-9083-B6FB2A349B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F722F-EB21-4902-A374-E95D4CAE7E36}" type="datetimeFigureOut">
              <a:rPr lang="zh-CN" altLang="en-US" smtClean="0"/>
              <a:t>2025/9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1258AC6-53D0-2065-50A7-B59A0E7F5C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16E54B0-3EC7-3F47-DD5E-C08A7A300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5B7DC-5966-45AC-92B7-C8CED918E5F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649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E600B6D-2030-1533-EA71-702E9E7A31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40F265E-222E-6859-1D1D-1BF27B8BF7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9A9B308-8C26-0351-40E9-6B8FFBD091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F722F-EB21-4902-A374-E95D4CAE7E36}" type="datetimeFigureOut">
              <a:rPr lang="zh-CN" altLang="en-US" smtClean="0"/>
              <a:t>2025/9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92217AA-1F5E-2313-1300-694F950DCB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CB7736C-04B4-3225-7434-CEF4A20B44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5B7DC-5966-45AC-92B7-C8CED918E5F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35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D85AFE-A33A-3FC7-EB20-0930435430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823F609-C22D-AAAA-76C1-122B1B1CE2E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81E953B-CF86-F25F-2EB8-BD5A40D444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DC29DB1-91E0-9052-C2F3-0700073090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F722F-EB21-4902-A374-E95D4CAE7E36}" type="datetimeFigureOut">
              <a:rPr lang="zh-CN" altLang="en-US" smtClean="0"/>
              <a:t>2025/9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50BCD9F-4291-1B97-AE3C-7F569F913A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A541EF3-6EED-639D-1F14-DC648AAE1B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5B7DC-5966-45AC-92B7-C8CED918E5F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94524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F47876A-900F-4FCF-4BD1-9E01EDDEA9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51FEFE4-7B9E-850D-4551-5DFCFF603E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51A5744-BE22-6863-FBA9-B2F49182D4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3FF0776-CC49-C17A-E857-82CB9120C1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790E599-B30E-A3FD-C3F8-0C8FABF999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C19127E-E248-26FC-2461-E5DE05624B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F722F-EB21-4902-A374-E95D4CAE7E36}" type="datetimeFigureOut">
              <a:rPr lang="zh-CN" altLang="en-US" smtClean="0"/>
              <a:t>2025/9/2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43448DC-0058-95A0-69F8-CB97B75E09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E2EBD65-12F5-CE27-1879-1598830AB0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5B7DC-5966-45AC-92B7-C8CED918E5F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0226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ABDEB75-45EC-C8EF-81CE-642036BFFD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B5EF42A-FD30-DC2B-411E-B838B45789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F722F-EB21-4902-A374-E95D4CAE7E36}" type="datetimeFigureOut">
              <a:rPr lang="zh-CN" altLang="en-US" smtClean="0"/>
              <a:t>2025/9/2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66FB817-F422-9CB6-59AB-1B4D93F00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ED132E2-B19C-C4BF-1250-17AD6FF4B7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5B7DC-5966-45AC-92B7-C8CED918E5F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96418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94538F7-0C92-1A51-1BF4-162703A0B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F722F-EB21-4902-A374-E95D4CAE7E36}" type="datetimeFigureOut">
              <a:rPr lang="zh-CN" altLang="en-US" smtClean="0"/>
              <a:t>2025/9/2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B4DDCF3-27DF-8AFF-2297-B43003271B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7D90F20-F722-02C2-F280-CB8D3F145D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5B7DC-5966-45AC-92B7-C8CED918E5F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0094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D820A1-8FA6-012D-8EEC-878043D40C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BF196C7-5687-003C-7D08-CE2F4FBFAB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8F6FBD9-021B-13C6-6A77-A1C9EF8B98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A169CAD-9DBC-EB97-DD38-147DFA93A8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F722F-EB21-4902-A374-E95D4CAE7E36}" type="datetimeFigureOut">
              <a:rPr lang="zh-CN" altLang="en-US" smtClean="0"/>
              <a:t>2025/9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D91FF54-6E3A-8E20-8415-79395A30AD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25CB041-0391-50EB-82FE-54DF2CA8B5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5B7DC-5966-45AC-92B7-C8CED918E5F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65223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78D3BA-B052-C853-48F4-1A2FFD759A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3A99413-77AA-B4BC-21CE-ECEDB7C85C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B7D8DD6-FFB3-C9F8-D792-88E1772BA5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035A133-F82C-8009-B8D8-5BF3030B50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F722F-EB21-4902-A374-E95D4CAE7E36}" type="datetimeFigureOut">
              <a:rPr lang="zh-CN" altLang="en-US" smtClean="0"/>
              <a:t>2025/9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A1B8C75-3618-F0B6-D5EB-0FB54F983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EC1E770-BC79-232B-DB27-6C483B2991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5B7DC-5966-45AC-92B7-C8CED918E5F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3262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CC0C294-324B-0B0C-B8B5-5CCD6F4C5E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EF35D86-9234-6CC3-3635-A93AAF34FD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EE9D592-7542-0B6B-55AF-FC74D80B8E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5F722F-EB21-4902-A374-E95D4CAE7E36}" type="datetimeFigureOut">
              <a:rPr lang="zh-CN" altLang="en-US" smtClean="0"/>
              <a:t>2025/9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DE27AE-7DD0-4E86-D201-9045A3963D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5AC780F-E492-822F-4C2F-8720E22760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75B7DC-5966-45AC-92B7-C8CED918E5F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5386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7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12" Type="http://schemas.openxmlformats.org/officeDocument/2006/relationships/image" Target="../media/image16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11" Type="http://schemas.openxmlformats.org/officeDocument/2006/relationships/image" Target="../media/image33.png"/><Relationship Id="rId5" Type="http://schemas.openxmlformats.org/officeDocument/2006/relationships/image" Target="../media/image27.png"/><Relationship Id="rId10" Type="http://schemas.openxmlformats.org/officeDocument/2006/relationships/image" Target="../media/image32.png"/><Relationship Id="rId4" Type="http://schemas.openxmlformats.org/officeDocument/2006/relationships/image" Target="../media/image26.png"/><Relationship Id="rId9" Type="http://schemas.openxmlformats.org/officeDocument/2006/relationships/image" Target="../media/image3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7" Type="http://schemas.openxmlformats.org/officeDocument/2006/relationships/image" Target="../media/image39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8.png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png"/><Relationship Id="rId3" Type="http://schemas.openxmlformats.org/officeDocument/2006/relationships/image" Target="../media/image41.png"/><Relationship Id="rId7" Type="http://schemas.openxmlformats.org/officeDocument/2006/relationships/image" Target="../media/image45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4.png"/><Relationship Id="rId11" Type="http://schemas.openxmlformats.org/officeDocument/2006/relationships/image" Target="../media/image49.png"/><Relationship Id="rId5" Type="http://schemas.openxmlformats.org/officeDocument/2006/relationships/image" Target="../media/image43.png"/><Relationship Id="rId10" Type="http://schemas.openxmlformats.org/officeDocument/2006/relationships/image" Target="../media/image48.png"/><Relationship Id="rId4" Type="http://schemas.openxmlformats.org/officeDocument/2006/relationships/image" Target="../media/image42.png"/><Relationship Id="rId9" Type="http://schemas.openxmlformats.org/officeDocument/2006/relationships/image" Target="../media/image4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873F338A-44F1-4C2A-01B9-837AD0C37A6B}"/>
              </a:ext>
            </a:extLst>
          </p:cNvPr>
          <p:cNvSpPr txBox="1"/>
          <p:nvPr/>
        </p:nvSpPr>
        <p:spPr>
          <a:xfrm>
            <a:off x="553792" y="573110"/>
            <a:ext cx="1590540" cy="367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Figure 4 H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77F66506-8EA7-AED0-3492-B3A0B0C790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4340" y="1440072"/>
            <a:ext cx="4130741" cy="2625032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CFC5E23D-6858-4536-6EFC-CFB06793394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88119" y="4651511"/>
            <a:ext cx="3694246" cy="1194260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07BC8C50-F61B-C4E9-02CE-653913316D3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17272" y="20993"/>
            <a:ext cx="4710388" cy="1419079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859493F3-7848-6977-8BB9-AD26A9BCA61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3663" y="3113323"/>
            <a:ext cx="3890355" cy="1419079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150F7941-7584-747D-4514-7374165C602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45094" y="1281817"/>
            <a:ext cx="4315135" cy="1849343"/>
          </a:xfrm>
          <a:prstGeom prst="rect">
            <a:avLst/>
          </a:prstGeom>
        </p:spPr>
      </p:pic>
      <p:sp>
        <p:nvSpPr>
          <p:cNvPr id="34" name="文本框 33">
            <a:extLst>
              <a:ext uri="{FF2B5EF4-FFF2-40B4-BE49-F238E27FC236}">
                <a16:creationId xmlns:a16="http://schemas.microsoft.com/office/drawing/2014/main" id="{CF35FE1F-7C71-A8BA-E1BF-8A37CA641751}"/>
              </a:ext>
            </a:extLst>
          </p:cNvPr>
          <p:cNvSpPr txBox="1"/>
          <p:nvPr/>
        </p:nvSpPr>
        <p:spPr>
          <a:xfrm>
            <a:off x="6136061" y="909125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PTGS2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B4DDD414-7660-9FF3-71C1-3CE3AC1D69BC}"/>
              </a:ext>
            </a:extLst>
          </p:cNvPr>
          <p:cNvSpPr txBox="1"/>
          <p:nvPr/>
        </p:nvSpPr>
        <p:spPr>
          <a:xfrm>
            <a:off x="6136061" y="2021822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TSPO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5797ECFB-BC2E-C74D-32A4-76580EFCEC8E}"/>
              </a:ext>
            </a:extLst>
          </p:cNvPr>
          <p:cNvSpPr txBox="1"/>
          <p:nvPr/>
        </p:nvSpPr>
        <p:spPr>
          <a:xfrm>
            <a:off x="6136061" y="3668663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GPX4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9F6E0E8B-AF69-08C9-B797-BD84680BC3A4}"/>
              </a:ext>
            </a:extLst>
          </p:cNvPr>
          <p:cNvSpPr txBox="1"/>
          <p:nvPr/>
        </p:nvSpPr>
        <p:spPr>
          <a:xfrm>
            <a:off x="6228826" y="5206851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CTB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cxnSp>
        <p:nvCxnSpPr>
          <p:cNvPr id="38" name="直接箭头连接符 37">
            <a:extLst>
              <a:ext uri="{FF2B5EF4-FFF2-40B4-BE49-F238E27FC236}">
                <a16:creationId xmlns:a16="http://schemas.microsoft.com/office/drawing/2014/main" id="{C416EDBE-B66E-F260-DC56-870ADD0176B6}"/>
              </a:ext>
            </a:extLst>
          </p:cNvPr>
          <p:cNvCxnSpPr>
            <a:cxnSpLocks/>
          </p:cNvCxnSpPr>
          <p:nvPr/>
        </p:nvCxnSpPr>
        <p:spPr>
          <a:xfrm flipH="1">
            <a:off x="10451162" y="693471"/>
            <a:ext cx="62596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8DE7AD92-C626-62F9-E253-D7E74E2BF8E1}"/>
              </a:ext>
            </a:extLst>
          </p:cNvPr>
          <p:cNvSpPr txBox="1"/>
          <p:nvPr/>
        </p:nvSpPr>
        <p:spPr>
          <a:xfrm>
            <a:off x="11077128" y="541279"/>
            <a:ext cx="988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接箭头连接符 39">
            <a:extLst>
              <a:ext uri="{FF2B5EF4-FFF2-40B4-BE49-F238E27FC236}">
                <a16:creationId xmlns:a16="http://schemas.microsoft.com/office/drawing/2014/main" id="{1079CD7B-1AF2-E306-1C86-848D332D133D}"/>
              </a:ext>
            </a:extLst>
          </p:cNvPr>
          <p:cNvCxnSpPr>
            <a:cxnSpLocks/>
          </p:cNvCxnSpPr>
          <p:nvPr/>
        </p:nvCxnSpPr>
        <p:spPr>
          <a:xfrm flipH="1">
            <a:off x="10391013" y="1985107"/>
            <a:ext cx="62596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97F95E65-297B-9B61-320D-D387EDC19AF7}"/>
              </a:ext>
            </a:extLst>
          </p:cNvPr>
          <p:cNvSpPr txBox="1"/>
          <p:nvPr/>
        </p:nvSpPr>
        <p:spPr>
          <a:xfrm>
            <a:off x="11016979" y="1832915"/>
            <a:ext cx="988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2E162250-FF26-C329-C462-FA8C3DBDB128}"/>
              </a:ext>
            </a:extLst>
          </p:cNvPr>
          <p:cNvCxnSpPr>
            <a:cxnSpLocks/>
          </p:cNvCxnSpPr>
          <p:nvPr/>
        </p:nvCxnSpPr>
        <p:spPr>
          <a:xfrm flipH="1">
            <a:off x="10577991" y="3413937"/>
            <a:ext cx="62596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E0D96EE7-88D2-868C-6FEF-49EC0719DD68}"/>
              </a:ext>
            </a:extLst>
          </p:cNvPr>
          <p:cNvSpPr txBox="1"/>
          <p:nvPr/>
        </p:nvSpPr>
        <p:spPr>
          <a:xfrm>
            <a:off x="11203957" y="3261745"/>
            <a:ext cx="988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直接箭头连接符 43">
            <a:extLst>
              <a:ext uri="{FF2B5EF4-FFF2-40B4-BE49-F238E27FC236}">
                <a16:creationId xmlns:a16="http://schemas.microsoft.com/office/drawing/2014/main" id="{C5B6B8CE-296D-7126-5808-6FCB23223250}"/>
              </a:ext>
            </a:extLst>
          </p:cNvPr>
          <p:cNvCxnSpPr>
            <a:cxnSpLocks/>
          </p:cNvCxnSpPr>
          <p:nvPr/>
        </p:nvCxnSpPr>
        <p:spPr>
          <a:xfrm flipH="1">
            <a:off x="10548052" y="5388264"/>
            <a:ext cx="62596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7468AFB1-4E1A-2ED9-54E1-70E9DF109406}"/>
              </a:ext>
            </a:extLst>
          </p:cNvPr>
          <p:cNvSpPr txBox="1"/>
          <p:nvPr/>
        </p:nvSpPr>
        <p:spPr>
          <a:xfrm>
            <a:off x="11174018" y="5236072"/>
            <a:ext cx="988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08259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A2350C24-DD51-FDCF-5439-8E43BD14D0EC}"/>
              </a:ext>
            </a:extLst>
          </p:cNvPr>
          <p:cNvSpPr txBox="1"/>
          <p:nvPr/>
        </p:nvSpPr>
        <p:spPr>
          <a:xfrm>
            <a:off x="553792" y="573110"/>
            <a:ext cx="3735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Figure 4H Repeated experiment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E3829385-077C-AF43-171C-098BA10E032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4469" y="4279342"/>
            <a:ext cx="3308942" cy="1055613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DB3C50AB-407D-45F2-AE8B-5F0B2C08654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0760" y="1097551"/>
            <a:ext cx="3308942" cy="1112441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D4B7A1AB-62D8-C804-FDD4-67F970DD2787}"/>
              </a:ext>
            </a:extLst>
          </p:cNvPr>
          <p:cNvSpPr txBox="1"/>
          <p:nvPr/>
        </p:nvSpPr>
        <p:spPr>
          <a:xfrm>
            <a:off x="132046" y="1553962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PTGS2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C304CCE-DD19-8D08-3AD8-0BE873D1ADA4}"/>
              </a:ext>
            </a:extLst>
          </p:cNvPr>
          <p:cNvSpPr txBox="1"/>
          <p:nvPr/>
        </p:nvSpPr>
        <p:spPr>
          <a:xfrm>
            <a:off x="132046" y="2462422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TSPO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21BFCA9-3C3A-3FBF-388D-388300ECE347}"/>
              </a:ext>
            </a:extLst>
          </p:cNvPr>
          <p:cNvSpPr txBox="1"/>
          <p:nvPr/>
        </p:nvSpPr>
        <p:spPr>
          <a:xfrm>
            <a:off x="132046" y="3370882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GPX4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B3D7CB6-1EB3-EBB1-95C5-F31E2579A3EE}"/>
              </a:ext>
            </a:extLst>
          </p:cNvPr>
          <p:cNvSpPr txBox="1"/>
          <p:nvPr/>
        </p:nvSpPr>
        <p:spPr>
          <a:xfrm>
            <a:off x="132046" y="4279342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CTB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5B17032A-EB13-7403-59C6-3D103B2E1BC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3146" y="4855734"/>
            <a:ext cx="3308942" cy="741065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49C68354-81F2-8E55-8378-002EC9DF7D3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2158" y="490740"/>
            <a:ext cx="3733800" cy="1129174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2C3C0867-B1A7-DF01-C4E2-E6432D6B26F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3146" y="1631733"/>
            <a:ext cx="3903520" cy="1869704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9AFA3397-8FB4-3B1E-29A7-E836FED0D0C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9720" y="1416396"/>
            <a:ext cx="3982280" cy="1866014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7CF4D5AE-783B-2BCE-5F96-6EE3E41D749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87376" y="3425793"/>
            <a:ext cx="3326373" cy="1866014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6C07D2C3-3534-3EEA-265D-1B8DA3EDEBC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41448" y="558204"/>
            <a:ext cx="3852418" cy="1022175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2CA157E1-7A38-4D18-2BF0-3D3A2A46EF6B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10278" y="2747814"/>
            <a:ext cx="2981163" cy="1212576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A03AB128-3196-A12F-6FB9-11AAB05416EE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2623" y="2686378"/>
            <a:ext cx="4265005" cy="2052178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4DA4C370-F0F3-B3D5-7A67-C4148443A66B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8860" y="3285511"/>
            <a:ext cx="2584221" cy="774175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E47639C8-E8CF-6BB0-627F-1FDD1217A090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7858" y="2225965"/>
            <a:ext cx="3024916" cy="8422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97993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72B8F2A9-1BCA-E0C1-F2E7-47A65584F666}"/>
              </a:ext>
            </a:extLst>
          </p:cNvPr>
          <p:cNvSpPr txBox="1"/>
          <p:nvPr/>
        </p:nvSpPr>
        <p:spPr>
          <a:xfrm>
            <a:off x="553792" y="573110"/>
            <a:ext cx="1590540" cy="367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Figure 7 A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8B10D922-9AFB-1F77-6216-0551B28081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6805" y="1487699"/>
            <a:ext cx="5096506" cy="3432172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B28BAFBA-9FBC-FBA5-F2DD-E40597321CC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93642" y="4597808"/>
            <a:ext cx="4046593" cy="2356514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73A106B4-9B39-9883-E3CA-FD9D495E809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07140" y="3237545"/>
            <a:ext cx="4295071" cy="1761549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DD6D0C80-D89B-2951-2082-68DB906D1CE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73563" y="1575775"/>
            <a:ext cx="4046593" cy="2208580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4802BB1A-277C-534C-096C-3DE6B98F046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11301" y="1000261"/>
            <a:ext cx="3486751" cy="1334379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66273C1B-293C-435C-2EC6-1DDE705CB39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73563" y="-277450"/>
            <a:ext cx="4295071" cy="1381840"/>
          </a:xfrm>
          <a:prstGeom prst="rect">
            <a:avLst/>
          </a:prstGeom>
        </p:spPr>
      </p:pic>
      <p:sp>
        <p:nvSpPr>
          <p:cNvPr id="42" name="文本框 41">
            <a:extLst>
              <a:ext uri="{FF2B5EF4-FFF2-40B4-BE49-F238E27FC236}">
                <a16:creationId xmlns:a16="http://schemas.microsoft.com/office/drawing/2014/main" id="{EEAC107A-4C80-9B4A-D46E-77C3FA7B96A5}"/>
              </a:ext>
            </a:extLst>
          </p:cNvPr>
          <p:cNvSpPr txBox="1"/>
          <p:nvPr/>
        </p:nvSpPr>
        <p:spPr>
          <a:xfrm>
            <a:off x="5857766" y="566767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PTGS2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61CC98AF-4131-576D-234D-15AE28CF5202}"/>
              </a:ext>
            </a:extLst>
          </p:cNvPr>
          <p:cNvSpPr txBox="1"/>
          <p:nvPr/>
        </p:nvSpPr>
        <p:spPr>
          <a:xfrm>
            <a:off x="5957674" y="1487699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TSPO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4B577836-F29E-DB90-214D-3DF561852476}"/>
              </a:ext>
            </a:extLst>
          </p:cNvPr>
          <p:cNvSpPr txBox="1"/>
          <p:nvPr/>
        </p:nvSpPr>
        <p:spPr>
          <a:xfrm>
            <a:off x="5986424" y="3933653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GPX4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B203B2AF-6343-CE2B-A36F-4135C8296742}"/>
              </a:ext>
            </a:extLst>
          </p:cNvPr>
          <p:cNvSpPr txBox="1"/>
          <p:nvPr/>
        </p:nvSpPr>
        <p:spPr>
          <a:xfrm>
            <a:off x="5886381" y="5776065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CTB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0596A778-8A81-4F19-E87C-B009F9FCB675}"/>
              </a:ext>
            </a:extLst>
          </p:cNvPr>
          <p:cNvSpPr txBox="1"/>
          <p:nvPr/>
        </p:nvSpPr>
        <p:spPr>
          <a:xfrm>
            <a:off x="5949453" y="2643115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FTMT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19BC1624-B3C8-9BE9-6F4B-D3AA15F7CAB1}"/>
              </a:ext>
            </a:extLst>
          </p:cNvPr>
          <p:cNvCxnSpPr>
            <a:cxnSpLocks/>
          </p:cNvCxnSpPr>
          <p:nvPr/>
        </p:nvCxnSpPr>
        <p:spPr>
          <a:xfrm flipH="1">
            <a:off x="10838788" y="276028"/>
            <a:ext cx="62596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091BC877-8258-7AE7-8AC1-D402CA4D1F4C}"/>
              </a:ext>
            </a:extLst>
          </p:cNvPr>
          <p:cNvSpPr txBox="1"/>
          <p:nvPr/>
        </p:nvSpPr>
        <p:spPr>
          <a:xfrm>
            <a:off x="11464754" y="123836"/>
            <a:ext cx="988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接箭头连接符 48">
            <a:extLst>
              <a:ext uri="{FF2B5EF4-FFF2-40B4-BE49-F238E27FC236}">
                <a16:creationId xmlns:a16="http://schemas.microsoft.com/office/drawing/2014/main" id="{6EF69228-2B92-2669-FDE7-016995C79B3F}"/>
              </a:ext>
            </a:extLst>
          </p:cNvPr>
          <p:cNvCxnSpPr>
            <a:cxnSpLocks/>
          </p:cNvCxnSpPr>
          <p:nvPr/>
        </p:nvCxnSpPr>
        <p:spPr>
          <a:xfrm flipH="1">
            <a:off x="10582223" y="1290116"/>
            <a:ext cx="62596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0C888319-4D79-7A10-A7A8-5E580A27CEEC}"/>
              </a:ext>
            </a:extLst>
          </p:cNvPr>
          <p:cNvSpPr txBox="1"/>
          <p:nvPr/>
        </p:nvSpPr>
        <p:spPr>
          <a:xfrm>
            <a:off x="11208189" y="1137924"/>
            <a:ext cx="988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1" name="直接箭头连接符 50">
            <a:extLst>
              <a:ext uri="{FF2B5EF4-FFF2-40B4-BE49-F238E27FC236}">
                <a16:creationId xmlns:a16="http://schemas.microsoft.com/office/drawing/2014/main" id="{4E7F2AC0-D6F3-9E50-E30E-9C22F773B0E3}"/>
              </a:ext>
            </a:extLst>
          </p:cNvPr>
          <p:cNvCxnSpPr>
            <a:cxnSpLocks/>
          </p:cNvCxnSpPr>
          <p:nvPr/>
        </p:nvCxnSpPr>
        <p:spPr>
          <a:xfrm flipH="1">
            <a:off x="10582223" y="2533227"/>
            <a:ext cx="62596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文本框 51">
            <a:extLst>
              <a:ext uri="{FF2B5EF4-FFF2-40B4-BE49-F238E27FC236}">
                <a16:creationId xmlns:a16="http://schemas.microsoft.com/office/drawing/2014/main" id="{ED8CD4B9-F2BA-A58C-C113-E3EE11467A09}"/>
              </a:ext>
            </a:extLst>
          </p:cNvPr>
          <p:cNvSpPr txBox="1"/>
          <p:nvPr/>
        </p:nvSpPr>
        <p:spPr>
          <a:xfrm>
            <a:off x="11208189" y="2381035"/>
            <a:ext cx="988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3" name="直接箭头连接符 52">
            <a:extLst>
              <a:ext uri="{FF2B5EF4-FFF2-40B4-BE49-F238E27FC236}">
                <a16:creationId xmlns:a16="http://schemas.microsoft.com/office/drawing/2014/main" id="{5D7FD019-DBEA-5ABC-4A42-440FEA798902}"/>
              </a:ext>
            </a:extLst>
          </p:cNvPr>
          <p:cNvCxnSpPr>
            <a:cxnSpLocks/>
          </p:cNvCxnSpPr>
          <p:nvPr/>
        </p:nvCxnSpPr>
        <p:spPr>
          <a:xfrm flipH="1">
            <a:off x="10715800" y="3622449"/>
            <a:ext cx="62596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2F91A165-1E04-B48F-35F6-B1C4787469AF}"/>
              </a:ext>
            </a:extLst>
          </p:cNvPr>
          <p:cNvSpPr txBox="1"/>
          <p:nvPr/>
        </p:nvSpPr>
        <p:spPr>
          <a:xfrm>
            <a:off x="11341766" y="3470257"/>
            <a:ext cx="988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接箭头连接符 54">
            <a:extLst>
              <a:ext uri="{FF2B5EF4-FFF2-40B4-BE49-F238E27FC236}">
                <a16:creationId xmlns:a16="http://schemas.microsoft.com/office/drawing/2014/main" id="{25EDFAD1-8A51-2E67-13BE-659F6BF0AACE}"/>
              </a:ext>
            </a:extLst>
          </p:cNvPr>
          <p:cNvCxnSpPr>
            <a:cxnSpLocks/>
          </p:cNvCxnSpPr>
          <p:nvPr/>
        </p:nvCxnSpPr>
        <p:spPr>
          <a:xfrm flipH="1">
            <a:off x="10548052" y="5388264"/>
            <a:ext cx="62596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1C0CA214-EAB2-B2EA-A1FC-E9912DE58501}"/>
              </a:ext>
            </a:extLst>
          </p:cNvPr>
          <p:cNvSpPr txBox="1"/>
          <p:nvPr/>
        </p:nvSpPr>
        <p:spPr>
          <a:xfrm>
            <a:off x="11174018" y="5236072"/>
            <a:ext cx="988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99232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46824B4B-FA78-4A4C-77FA-EB620419467F}"/>
              </a:ext>
            </a:extLst>
          </p:cNvPr>
          <p:cNvSpPr txBox="1"/>
          <p:nvPr/>
        </p:nvSpPr>
        <p:spPr>
          <a:xfrm>
            <a:off x="391245" y="487254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PTGS2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4E36D75A-B817-4AE8-855C-4F3BE6E88AD3}"/>
              </a:ext>
            </a:extLst>
          </p:cNvPr>
          <p:cNvSpPr txBox="1"/>
          <p:nvPr/>
        </p:nvSpPr>
        <p:spPr>
          <a:xfrm>
            <a:off x="491153" y="1408186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TSPO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7CE1F140-6988-FCE8-A5C5-4E8057528E29}"/>
              </a:ext>
            </a:extLst>
          </p:cNvPr>
          <p:cNvSpPr txBox="1"/>
          <p:nvPr/>
        </p:nvSpPr>
        <p:spPr>
          <a:xfrm>
            <a:off x="519903" y="3854140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GPX4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3895931-E7D9-8872-769A-ACE40D14169F}"/>
              </a:ext>
            </a:extLst>
          </p:cNvPr>
          <p:cNvSpPr txBox="1"/>
          <p:nvPr/>
        </p:nvSpPr>
        <p:spPr>
          <a:xfrm>
            <a:off x="419860" y="5696552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CTB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0AB7A62-8BD0-ABDE-2CC6-618F35151412}"/>
              </a:ext>
            </a:extLst>
          </p:cNvPr>
          <p:cNvSpPr txBox="1"/>
          <p:nvPr/>
        </p:nvSpPr>
        <p:spPr>
          <a:xfrm>
            <a:off x="482932" y="2563602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FTMT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EA5EE483-604E-2E1A-997D-80024C2B9159}"/>
              </a:ext>
            </a:extLst>
          </p:cNvPr>
          <p:cNvSpPr txBox="1"/>
          <p:nvPr/>
        </p:nvSpPr>
        <p:spPr>
          <a:xfrm>
            <a:off x="391245" y="117648"/>
            <a:ext cx="3735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Figure 7 I Repeated experiment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E8273B4C-9E85-6429-95DD-62009E05BA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5940" y="2563602"/>
            <a:ext cx="3193381" cy="1077285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A2E19CE2-10ED-5FB0-2067-A8DC11468DA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3839" y="453212"/>
            <a:ext cx="3298324" cy="988742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595DA498-2036-DE4D-3EE2-8D758FDB595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8847" y="1288344"/>
            <a:ext cx="3193381" cy="1325483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2574A6BF-948E-6D14-7049-6F28210E50A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4497" y="3415191"/>
            <a:ext cx="3882786" cy="1716304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B46B8EBA-B913-93C9-45B9-D7A4390EF60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755" y="4762535"/>
            <a:ext cx="4229935" cy="2057940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10F94593-964A-B55E-CEB4-82B2EF5F327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4176719"/>
            <a:ext cx="5413512" cy="2955975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2E2825A7-0EC6-2880-5E0A-1821AED689F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5071" y="3858513"/>
            <a:ext cx="3962432" cy="904022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F11ACDCC-33D8-CFAC-0E03-2F04A3CF0E25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8522" y="1481461"/>
            <a:ext cx="4685525" cy="757889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9D3637CD-C5F0-543F-2390-AB540BA5164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97839" y="39868"/>
            <a:ext cx="4346890" cy="1264024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B81BDB3F-50F4-296C-C5A0-1478403B151E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43960" y="2557556"/>
            <a:ext cx="3500769" cy="6396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10801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0E9D8D6A-0C22-9EB1-C033-2FA470DC5888}"/>
              </a:ext>
            </a:extLst>
          </p:cNvPr>
          <p:cNvSpPr txBox="1"/>
          <p:nvPr/>
        </p:nvSpPr>
        <p:spPr>
          <a:xfrm>
            <a:off x="553791" y="573110"/>
            <a:ext cx="3869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Supplementary Figure 1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69C703B6-13A2-7ADC-EE5F-C4C6276D3C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93151" y="5413303"/>
            <a:ext cx="3316524" cy="123798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22032502-0EB6-2EC3-F820-4431024863D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99680" y="107337"/>
            <a:ext cx="3160087" cy="1127543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64C14E10-50CF-01B3-040E-C1F383224C3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1827" y="930337"/>
            <a:ext cx="2875613" cy="1222483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A5CAFBF8-6058-2C2A-EDF0-4621BABDB58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46986" y="3237833"/>
            <a:ext cx="3808854" cy="1809926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09244B9D-368C-DCE3-00B4-7C56C19D44B9}"/>
              </a:ext>
            </a:extLst>
          </p:cNvPr>
          <p:cNvSpPr txBox="1"/>
          <p:nvPr/>
        </p:nvSpPr>
        <p:spPr>
          <a:xfrm>
            <a:off x="5907697" y="745671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PTGS2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FD5F0D9-67DD-C954-6080-AA7B596F507B}"/>
              </a:ext>
            </a:extLst>
          </p:cNvPr>
          <p:cNvSpPr txBox="1"/>
          <p:nvPr/>
        </p:nvSpPr>
        <p:spPr>
          <a:xfrm>
            <a:off x="6007605" y="1666603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TSPO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EDEDE3D-54CE-1274-6C85-A6BB91AEAAB7}"/>
              </a:ext>
            </a:extLst>
          </p:cNvPr>
          <p:cNvSpPr txBox="1"/>
          <p:nvPr/>
        </p:nvSpPr>
        <p:spPr>
          <a:xfrm>
            <a:off x="6036355" y="4112557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GPX4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A8AA093-88F3-9F8D-2D11-127F11A3A17D}"/>
              </a:ext>
            </a:extLst>
          </p:cNvPr>
          <p:cNvSpPr txBox="1"/>
          <p:nvPr/>
        </p:nvSpPr>
        <p:spPr>
          <a:xfrm>
            <a:off x="5936312" y="5954969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CTB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73C45C0-97BF-2E6D-D09A-B4390F7F4634}"/>
              </a:ext>
            </a:extLst>
          </p:cNvPr>
          <p:cNvSpPr txBox="1"/>
          <p:nvPr/>
        </p:nvSpPr>
        <p:spPr>
          <a:xfrm>
            <a:off x="5999384" y="2822019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FTMT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id="{1890A9F1-4D71-2848-CE57-D5D8534A59B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5897" y="957200"/>
            <a:ext cx="5315088" cy="4997769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7C9C00DA-5FAC-308D-9683-7FE318C74FD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0564371">
            <a:off x="7424700" y="2327218"/>
            <a:ext cx="2707868" cy="14154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72909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25DA88E-FCE1-D1C3-8311-C8E3CB523AB3}"/>
              </a:ext>
            </a:extLst>
          </p:cNvPr>
          <p:cNvSpPr txBox="1"/>
          <p:nvPr/>
        </p:nvSpPr>
        <p:spPr>
          <a:xfrm>
            <a:off x="391245" y="487254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PTGS2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B93136D0-1618-799C-80A0-CFBFBC62D9AB}"/>
              </a:ext>
            </a:extLst>
          </p:cNvPr>
          <p:cNvSpPr txBox="1"/>
          <p:nvPr/>
        </p:nvSpPr>
        <p:spPr>
          <a:xfrm>
            <a:off x="491153" y="1408186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TSPO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599A20E-982C-A558-FB90-8C6C479BE068}"/>
              </a:ext>
            </a:extLst>
          </p:cNvPr>
          <p:cNvSpPr txBox="1"/>
          <p:nvPr/>
        </p:nvSpPr>
        <p:spPr>
          <a:xfrm>
            <a:off x="519903" y="3854140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GPX4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301F7D18-2590-5700-6EDF-4A25BC5855DE}"/>
              </a:ext>
            </a:extLst>
          </p:cNvPr>
          <p:cNvSpPr txBox="1"/>
          <p:nvPr/>
        </p:nvSpPr>
        <p:spPr>
          <a:xfrm>
            <a:off x="419860" y="5696552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CTB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D5991D0-08B3-5715-A152-825E929C0897}"/>
              </a:ext>
            </a:extLst>
          </p:cNvPr>
          <p:cNvSpPr txBox="1"/>
          <p:nvPr/>
        </p:nvSpPr>
        <p:spPr>
          <a:xfrm>
            <a:off x="482932" y="2563602"/>
            <a:ext cx="1147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FTMT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5430DCA-C959-3F55-4439-E54EAF3A0CAB}"/>
              </a:ext>
            </a:extLst>
          </p:cNvPr>
          <p:cNvSpPr txBox="1"/>
          <p:nvPr/>
        </p:nvSpPr>
        <p:spPr>
          <a:xfrm>
            <a:off x="391244" y="117648"/>
            <a:ext cx="58641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Supplementary Figure 2I Repeated experiment</a:t>
            </a:r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B1919546-4392-08D1-087E-39DD85A80D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6800" y="527126"/>
            <a:ext cx="2593284" cy="1152571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FBA08EF0-1D2A-0372-AC19-A637207380B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088362">
            <a:off x="6573779" y="-347988"/>
            <a:ext cx="4017410" cy="2374932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7AB66A6F-54BC-7902-CC84-671C53D78CC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6801" y="1634276"/>
            <a:ext cx="2782857" cy="1018118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D3CAE063-176F-B72C-64C2-FB29934452B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34942" y="1228378"/>
            <a:ext cx="3476503" cy="1018119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4A95F7CA-3FEB-DD6B-FB17-06531C8CD90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26097" y="2196463"/>
            <a:ext cx="3434434" cy="15292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CE2EC8C8-7146-82C4-415F-B1C610A1374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5697" y="4204004"/>
            <a:ext cx="2885389" cy="1267736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8382B566-CD5B-A4C4-1445-9CE0E755BF2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1974" y="3597431"/>
            <a:ext cx="4227642" cy="2127636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E1CFBE8D-A589-7C4D-8491-7799AF083965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1469" y="5249497"/>
            <a:ext cx="4337822" cy="1608502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E2990307-C56E-5293-0F7E-C58F2BF9028E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80179" y="5471548"/>
            <a:ext cx="3329437" cy="1491925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7C37F351-4499-8714-E282-80FF0030CAB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310778">
            <a:off x="1892592" y="2681576"/>
            <a:ext cx="2861410" cy="12723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27869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</TotalTime>
  <Words>60</Words>
  <Application>Microsoft Office PowerPoint</Application>
  <PresentationFormat>宽屏</PresentationFormat>
  <Paragraphs>43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2" baseType="lpstr">
      <vt:lpstr>等线</vt:lpstr>
      <vt:lpstr>等线 Light</vt:lpstr>
      <vt:lpstr>微软雅黑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EN ZOU</dc:creator>
  <cp:lastModifiedBy>CHEN ZOU</cp:lastModifiedBy>
  <cp:revision>3</cp:revision>
  <dcterms:created xsi:type="dcterms:W3CDTF">2025-05-22T14:37:31Z</dcterms:created>
  <dcterms:modified xsi:type="dcterms:W3CDTF">2025-09-24T16:04:16Z</dcterms:modified>
</cp:coreProperties>
</file>